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C09553-53EC-4D34-8ACE-B53CC098511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767D70-0C21-4D9B-B34A-D71D90C4661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C8E247-C2A4-449A-B427-7AA7CD5F47F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50D338-D882-4DD1-A0C8-79F6B398EFE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C65A68-7078-437F-9ED6-CB20517155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44436C-2089-4254-BDBE-067AF596F99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6E0CF9-AA8D-4928-A7C1-DC03D9EF93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18EFF-593D-4F85-AB5F-820B964F081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642E0B-41EA-4A70-9ADE-18C52E53BD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51645-743B-43E8-ABAC-7EC33C33DC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E28776-51CE-4CCF-AF4F-6FA22F0D0EA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718600-071C-4307-81C8-2C1E59AC65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8549CB8-388C-4828-8278-E9381EEA473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23800" y="504720"/>
            <a:ext cx="3772800" cy="5839200"/>
            <a:chOff x="523800" y="504720"/>
            <a:chExt cx="3772800" cy="5839200"/>
          </a:xfrm>
        </p:grpSpPr>
        <p:sp>
          <p:nvSpPr>
            <p:cNvPr id="42" name=""/>
            <p:cNvSpPr/>
            <p:nvPr/>
          </p:nvSpPr>
          <p:spPr>
            <a:xfrm>
              <a:off x="523800" y="1857240"/>
              <a:ext cx="1526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 flipV="1">
              <a:off x="676440" y="1190520"/>
              <a:ext cx="0" cy="666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676440" y="1190520"/>
              <a:ext cx="856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V="1">
              <a:off x="762120" y="1066680"/>
              <a:ext cx="0" cy="123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62120" y="1066680"/>
              <a:ext cx="704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>
              <a:off x="1467000" y="857160"/>
              <a:ext cx="0" cy="209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467000" y="857160"/>
              <a:ext cx="361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 flipV="1">
              <a:off x="1828800" y="676440"/>
              <a:ext cx="0" cy="180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1828800" y="676440"/>
              <a:ext cx="390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 flipV="1">
              <a:off x="2219400" y="571320"/>
              <a:ext cx="0" cy="105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219400" y="571320"/>
              <a:ext cx="666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219400" y="67644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219400" y="781200"/>
              <a:ext cx="457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828800" y="857160"/>
              <a:ext cx="0" cy="2192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828800" y="1076400"/>
              <a:ext cx="685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 flipV="1">
              <a:off x="2514600" y="980640"/>
              <a:ext cx="0" cy="95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514600" y="981000"/>
              <a:ext cx="428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514600" y="10764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514600" y="1181160"/>
              <a:ext cx="6094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1467000" y="1066680"/>
              <a:ext cx="0" cy="324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1467000" y="1390680"/>
              <a:ext cx="1028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62120" y="1190520"/>
              <a:ext cx="0" cy="4003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762120" y="1590840"/>
              <a:ext cx="2276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76440" y="1857240"/>
              <a:ext cx="0" cy="95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76440" y="1952640"/>
              <a:ext cx="10000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1676520" y="1790640"/>
              <a:ext cx="0" cy="162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676520" y="1790640"/>
              <a:ext cx="733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676520" y="1952640"/>
              <a:ext cx="0" cy="15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676520" y="2104920"/>
              <a:ext cx="723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2400120" y="19998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400120" y="2000160"/>
              <a:ext cx="7527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400120" y="2104920"/>
              <a:ext cx="0" cy="954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400120" y="2200320"/>
              <a:ext cx="362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676440" y="1857240"/>
              <a:ext cx="0" cy="28101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76440" y="4667400"/>
              <a:ext cx="342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1019160" y="3514680"/>
              <a:ext cx="0" cy="1152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019160" y="3514680"/>
              <a:ext cx="133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1152360" y="2790360"/>
              <a:ext cx="0" cy="7239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152360" y="2790720"/>
              <a:ext cx="219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1371600" y="2610000"/>
              <a:ext cx="0" cy="1807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371600" y="2610000"/>
              <a:ext cx="3999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1771560" y="2399760"/>
              <a:ext cx="0" cy="2098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771560" y="2400120"/>
              <a:ext cx="1905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771560" y="261000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771560" y="2705040"/>
              <a:ext cx="333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2104920" y="261000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104920" y="2610000"/>
              <a:ext cx="657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104920" y="270504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104920" y="2809800"/>
              <a:ext cx="704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371600" y="2790720"/>
              <a:ext cx="0" cy="3240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371600" y="3114720"/>
              <a:ext cx="1200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2571840" y="30096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2571840" y="3009960"/>
              <a:ext cx="352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2571840" y="311472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2571840" y="3219480"/>
              <a:ext cx="304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152360" y="3514680"/>
              <a:ext cx="0" cy="800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1152360" y="4314960"/>
              <a:ext cx="304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1457280" y="3962160"/>
              <a:ext cx="0" cy="3524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1457280" y="3962520"/>
              <a:ext cx="2286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1685880" y="3524040"/>
              <a:ext cx="0" cy="438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1685880" y="3524400"/>
              <a:ext cx="5144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2200320" y="341928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2200320" y="3419640"/>
              <a:ext cx="1332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2200320" y="3524400"/>
              <a:ext cx="0" cy="950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2200320" y="3619440"/>
              <a:ext cx="47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685880" y="3962520"/>
              <a:ext cx="0" cy="3715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685880" y="4334040"/>
              <a:ext cx="31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2000160" y="4057560"/>
              <a:ext cx="0" cy="2764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2000160" y="4057560"/>
              <a:ext cx="57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2057400" y="3828600"/>
              <a:ext cx="0" cy="228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2057400" y="3828960"/>
              <a:ext cx="114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2057400" y="4057560"/>
              <a:ext cx="0" cy="228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2057400" y="4286160"/>
              <a:ext cx="152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2209680" y="4114800"/>
              <a:ext cx="0" cy="1713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2209680" y="4114800"/>
              <a:ext cx="238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V="1">
              <a:off x="2448000" y="4029120"/>
              <a:ext cx="0" cy="856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880" bIns="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2448000" y="4029120"/>
              <a:ext cx="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448000" y="4114800"/>
              <a:ext cx="0" cy="114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2448000" y="4228920"/>
              <a:ext cx="6001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2209680" y="4286160"/>
              <a:ext cx="0" cy="152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2209680" y="4438800"/>
              <a:ext cx="28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2000160" y="4334040"/>
              <a:ext cx="0" cy="304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2000160" y="4638600"/>
              <a:ext cx="133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1457280" y="4314960"/>
              <a:ext cx="0" cy="6285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1457280" y="4943520"/>
              <a:ext cx="10098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2467080" y="48384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2467080" y="4838760"/>
              <a:ext cx="304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2467080" y="494352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2467080" y="5048280"/>
              <a:ext cx="3427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1019160" y="4667400"/>
              <a:ext cx="0" cy="11048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1019160" y="5772240"/>
              <a:ext cx="1238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1143000" y="5477040"/>
              <a:ext cx="0" cy="2952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1143000" y="5477040"/>
              <a:ext cx="3142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1457280" y="5248080"/>
              <a:ext cx="0" cy="228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1457280" y="5248440"/>
              <a:ext cx="32400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1457280" y="5477040"/>
              <a:ext cx="0" cy="228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1457280" y="5705640"/>
              <a:ext cx="3049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1762200" y="5553000"/>
              <a:ext cx="0" cy="15264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1762200" y="5553000"/>
              <a:ext cx="1713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1933560" y="544788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1933560" y="5448240"/>
              <a:ext cx="5724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1933560" y="555300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1933560" y="5657760"/>
              <a:ext cx="381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762200" y="5705640"/>
              <a:ext cx="0" cy="15228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1762200" y="5857920"/>
              <a:ext cx="2095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143000" y="5772240"/>
              <a:ext cx="0" cy="39060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1143000" y="6162840"/>
              <a:ext cx="57132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1714320" y="6057720"/>
              <a:ext cx="0" cy="10512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1714320" y="6057720"/>
              <a:ext cx="13356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1714320" y="6162840"/>
              <a:ext cx="0" cy="10476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1714320" y="6267600"/>
              <a:ext cx="209880" cy="0"/>
            </a:xfrm>
            <a:prstGeom prst="line">
              <a:avLst/>
            </a:prstGeom>
            <a:ln w="158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2948400" y="50472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391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2728080" y="70488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153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005640" y="90504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391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3175920" y="11145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153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2557800" y="131436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391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3083400" y="151452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272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2468880" y="1724040"/>
              <a:ext cx="864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333399"/>
                  </a:solidFill>
                  <a:latin typeface="Times New Roman"/>
                </a:rPr>
                <a:t>At4g00650_FR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3215160" y="192420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634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2823480" y="212400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015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3721320" y="233352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2723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2806920" y="253368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1g318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2854800" y="274320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163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2996280" y="294336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093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2928240" y="31431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716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2378520" y="335268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4g149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2292840" y="355284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3g224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2234160" y="375300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7g076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2520000" y="396252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580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3110400" y="416232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3g478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2299680" y="436248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056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2194560" y="457200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560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2843640" y="477216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1g085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2861640" y="497196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2g051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825920" y="5181480"/>
              <a:ext cx="575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At5g4838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2062800" y="538164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9g073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2034000" y="558180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9g073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2032920" y="579132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4g087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919880" y="5991120"/>
              <a:ext cx="653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Os07g402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1975680" y="6191280"/>
              <a:ext cx="596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Times New Roman"/>
                </a:rPr>
                <a:t>Bd1g228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82" name=""/>
          <p:cNvSpPr/>
          <p:nvPr/>
        </p:nvSpPr>
        <p:spPr>
          <a:xfrm>
            <a:off x="1890000" y="333360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985400" y="49680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2264760" y="293040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842400" y="574344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756800" y="414972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1207440" y="41241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7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1407600" y="597852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1448640" y="551808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626480" y="5375160"/>
            <a:ext cx="3726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2215800" y="8906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1223280" y="87948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2160000" y="191772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8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426680" y="17733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586880" y="66528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5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2220480" y="476244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1217160" y="5283360"/>
            <a:ext cx="3088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9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4210200" y="547560"/>
            <a:ext cx="1440" cy="1714680"/>
          </a:xfrm>
          <a:custGeom>
            <a:avLst/>
            <a:gdLst/>
            <a:ahLst/>
            <a:rect l="l" t="t" r="r" b="b"/>
            <a:pathLst>
              <a:path w="1" h="1080">
                <a:moveTo>
                  <a:pt x="1" y="1"/>
                </a:moveTo>
                <a:lnTo>
                  <a:pt x="0" y="0"/>
                </a:lnTo>
                <a:lnTo>
                  <a:pt x="0" y="1080"/>
                </a:lnTo>
              </a:path>
            </a:pathLst>
          </a:custGeom>
          <a:noFill/>
          <a:ln w="255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5364000" y="4797360"/>
            <a:ext cx="2592720" cy="1292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At = Arabidopsi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Os = Ric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d = Brachypodiu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Bootstrap support of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  <a:ea typeface="Arial"/>
              </a:rPr>
              <a:t>≥ </a:t>
            </a: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90% show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Arial"/>
              </a:rPr>
              <a:t>(1000 datasets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4356000" y="1052640"/>
            <a:ext cx="27370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876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</a:rPr>
              <a:t>FRI and related clade selected for tree in figure 13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3924360" y="549360"/>
            <a:ext cx="288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3924360" y="2257560"/>
            <a:ext cx="288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22T14:02:18Z</dcterms:created>
  <dc:creator>Janet Higgins</dc:creator>
  <dc:description/>
  <dc:language>en-US</dc:language>
  <cp:lastModifiedBy>Janet Higgins</cp:lastModifiedBy>
  <dcterms:modified xsi:type="dcterms:W3CDTF">2010-01-06T12:12:20Z</dcterms:modified>
  <cp:revision>10</cp:revision>
  <dc:subject/>
  <dc:title>Slide 1</dc:title>
</cp:coreProperties>
</file>